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FADEC7-8711-4B93-97E0-D20F426EF4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5D3757-7B9B-4899-BB64-AAF89F3674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B6C619-EECA-4351-A687-346F49FCAC3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96F06-EBDA-4049-B6DD-0A22DFF793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97CE0-EA25-4C91-8E58-B08CDDB6D1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93C6EE-B239-4340-8752-26C9D45E76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4B43C5-EC83-4422-9A65-4DECB055A7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1E766-2CC1-4356-958B-F4E230DE1E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4FD6B4-BF6B-499A-9BCE-BFD77CC976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834D4A-3362-45C8-A6B7-006E1C974B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80F3F8-9F9E-486B-9E98-B329405D29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FF839-96CA-4738-903A-6B0AAE5938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25F9C0-00EC-4C51-8363-BC69FB3C62D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413000" y="855720"/>
          <a:ext cx="4162320" cy="4394160"/>
        </p:xfrm>
        <a:graphic>
          <a:graphicData uri="http://schemas.openxmlformats.org/drawingml/2006/table">
            <a:tbl>
              <a:tblPr/>
              <a:tblGrid>
                <a:gridCol w="1230480"/>
                <a:gridCol w="1143000"/>
                <a:gridCol w="649080"/>
                <a:gridCol w="1139760"/>
              </a:tblGrid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TARGET GEN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RNA SAMP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SLO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EFFICIENC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e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Bas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4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6.4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e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4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5.8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e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1 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39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6.9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e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2 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4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5.6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e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3 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44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5.1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n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Bas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4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4.8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n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4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5.4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n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1 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4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6.1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n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2 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4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5.6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n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3 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4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4.4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i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Bas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38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7.4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i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3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7.7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i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1 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3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8.5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i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2 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3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7.2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i-N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3 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-3.36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98.1 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1346040" y="395280"/>
            <a:ext cx="4248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Table 1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: Efficiency for target genes. Efficiency was calculated as 10 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</a:rPr>
              <a:t>(-1/Slope)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rot="16200000">
            <a:off x="-487800" y="6445800"/>
            <a:ext cx="1944720" cy="292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Gene Expression Index (C</a:t>
            </a:r>
            <a:r>
              <a:rPr b="0" lang="it-IT" sz="1000" spc="-1" strike="noStrike" baseline="-25000">
                <a:solidFill>
                  <a:srgbClr val="000000"/>
                </a:solidFill>
                <a:latin typeface="Times New Roman"/>
              </a:rPr>
              <a:t>T</a:t>
            </a: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33360" y="7853400"/>
            <a:ext cx="31669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Figure 1: </a:t>
            </a: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Regression lines for G3PDH gene showing predicted regression lines and actual means. </a:t>
            </a:r>
            <a:r>
              <a:rPr b="0" i="1" lang="it-IT" sz="1200" spc="-1" strike="noStrike">
                <a:solidFill>
                  <a:srgbClr val="000000"/>
                </a:solidFill>
                <a:latin typeface="Times New Roman"/>
              </a:rPr>
              <a:t>G3PDH</a:t>
            </a: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has low slope and close fit to the regression lin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563920" y="7588080"/>
            <a:ext cx="86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sampl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860640" y="5900760"/>
            <a:ext cx="238608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Table 2.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Means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± SEM of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r>
              <a:rPr b="0" lang="it-IT" sz="1200" spc="-1" strike="noStrike" baseline="-25000">
                <a:solidFill>
                  <a:srgbClr val="000000"/>
                </a:solidFill>
                <a:latin typeface="Times New Roman"/>
              </a:rPr>
              <a:t>T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 value for G3PDH housekeeping gene</a:t>
            </a: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tested in the samples us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7" name=""/>
          <p:cNvGraphicFramePr/>
          <p:nvPr/>
        </p:nvGraphicFramePr>
        <p:xfrm>
          <a:off x="3927600" y="6537240"/>
          <a:ext cx="2200320" cy="1922400"/>
        </p:xfrm>
        <a:graphic>
          <a:graphicData uri="http://schemas.openxmlformats.org/drawingml/2006/table">
            <a:tbl>
              <a:tblPr/>
              <a:tblGrid>
                <a:gridCol w="758880"/>
                <a:gridCol w="755640"/>
                <a:gridCol w="685800"/>
              </a:tblGrid>
              <a:tr h="276480">
                <a:tc row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samp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G3PD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08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C</a:t>
                      </a:r>
                      <a:r>
                        <a:rPr b="0" lang="it-IT" sz="1200" spc="-1" strike="noStrike" baseline="-30000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T</a:t>
                      </a: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 me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C</a:t>
                      </a:r>
                      <a:r>
                        <a:rPr b="0" lang="en-US" sz="1200" spc="-1" strike="noStrike" baseline="-30000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T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SE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BAS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18.501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0.173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18.383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0.106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1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17.281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0.098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2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18.272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0.162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3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18.785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0.217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8" name=""/>
          <p:cNvSpPr/>
          <p:nvPr/>
        </p:nvSpPr>
        <p:spPr>
          <a:xfrm>
            <a:off x="936720" y="5979960"/>
            <a:ext cx="1440" cy="1414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895320" y="7388280"/>
            <a:ext cx="367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895320" y="7216920"/>
            <a:ext cx="3672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895320" y="7039080"/>
            <a:ext cx="367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895320" y="6861240"/>
            <a:ext cx="367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895320" y="6684840"/>
            <a:ext cx="367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895320" y="6507000"/>
            <a:ext cx="367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895320" y="6335640"/>
            <a:ext cx="367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895320" y="6157800"/>
            <a:ext cx="367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895320" y="5979960"/>
            <a:ext cx="367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936720" y="7396200"/>
            <a:ext cx="20588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1314360" y="7396200"/>
            <a:ext cx="6480" cy="54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1692360" y="7396200"/>
            <a:ext cx="6120" cy="54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V="1">
            <a:off x="2070000" y="7396200"/>
            <a:ext cx="6480" cy="54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2454120" y="7396200"/>
            <a:ext cx="6480" cy="54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V="1">
            <a:off x="2832120" y="7396200"/>
            <a:ext cx="6480" cy="54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314360" y="6408720"/>
            <a:ext cx="1517760" cy="184320"/>
          </a:xfrm>
          <a:custGeom>
            <a:avLst/>
            <a:gdLst/>
            <a:ahLst/>
            <a:rect l="l" t="t" r="r" b="b"/>
            <a:pathLst>
              <a:path w="265" h="32">
                <a:moveTo>
                  <a:pt x="0" y="17"/>
                </a:moveTo>
                <a:lnTo>
                  <a:pt x="66" y="25"/>
                </a:lnTo>
                <a:lnTo>
                  <a:pt x="133" y="31"/>
                </a:lnTo>
                <a:lnTo>
                  <a:pt x="199" y="32"/>
                </a:lnTo>
                <a:lnTo>
                  <a:pt x="265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V="1">
            <a:off x="1314360" y="6450120"/>
            <a:ext cx="0" cy="56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298520" y="6450120"/>
            <a:ext cx="39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flipV="1">
            <a:off x="1692360" y="651204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676520" y="6512040"/>
            <a:ext cx="39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V="1">
            <a:off x="2076480" y="6552720"/>
            <a:ext cx="0" cy="33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058840" y="6553080"/>
            <a:ext cx="39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V="1">
            <a:off x="2454120" y="6535440"/>
            <a:ext cx="0" cy="57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436840" y="6535800"/>
            <a:ext cx="39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V="1">
            <a:off x="2832120" y="6335280"/>
            <a:ext cx="0" cy="73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814480" y="6335640"/>
            <a:ext cx="39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285920" y="6478560"/>
            <a:ext cx="57240" cy="572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663560" y="6524640"/>
            <a:ext cx="57240" cy="572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048040" y="6558120"/>
            <a:ext cx="56880" cy="5688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425680" y="6564240"/>
            <a:ext cx="57240" cy="572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803680" y="6380280"/>
            <a:ext cx="56880" cy="5688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314360" y="6496200"/>
            <a:ext cx="1517760" cy="68040"/>
          </a:xfrm>
          <a:custGeom>
            <a:avLst/>
            <a:gdLst/>
            <a:ahLst/>
            <a:rect l="l" t="t" r="r" b="b"/>
            <a:pathLst>
              <a:path w="265" h="12">
                <a:moveTo>
                  <a:pt x="0" y="12"/>
                </a:moveTo>
                <a:lnTo>
                  <a:pt x="66" y="9"/>
                </a:lnTo>
                <a:lnTo>
                  <a:pt x="133" y="6"/>
                </a:lnTo>
                <a:lnTo>
                  <a:pt x="199" y="3"/>
                </a:lnTo>
                <a:lnTo>
                  <a:pt x="265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624680" y="6261120"/>
            <a:ext cx="1040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y = 0,045x + 18,3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626400" y="73072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30720" y="71359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6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631080" y="69613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35400" y="67867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7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640440" y="66056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645120" y="642456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8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645480" y="62596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649800" y="60786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9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654840" y="58910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185840" y="7416720"/>
            <a:ext cx="22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    ME     1h      2h      3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17T13:33:06Z</dcterms:created>
  <dc:creator>DB</dc:creator>
  <dc:description/>
  <dc:language>en-US</dc:language>
  <cp:lastModifiedBy>DB</cp:lastModifiedBy>
  <dcterms:modified xsi:type="dcterms:W3CDTF">2014-12-03T11:10:00Z</dcterms:modified>
  <cp:revision>14</cp:revision>
  <dc:subject/>
  <dc:title>Diapositiva 1</dc:title>
</cp:coreProperties>
</file>